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3454C5-A578-440E-A5A3-886589F5A15C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203ECC-2B76-4C7C-8076-B6CC71CE432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8772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1919DB-093B-2E2F-EEEA-728BB31E75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A4D596C-B5B1-2A64-E5DF-316690D103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E582488-C665-FA35-32A9-F1C439D41B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DEE483D-0619-F334-39B2-20F14E06A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C6B080C-2BC4-AF2B-452B-577A693D3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634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BA8EE4C-12ED-DDBE-B8B7-28D28BFF98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F1F2D8B-809B-4F54-230F-AB02A8EFAF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2DA90-B42F-64B7-143D-C0379A09C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21F14E2-CE60-3C8F-973A-F9DDF4EA2E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38187BB-FDD8-4D0D-CD4D-0719F3ABAB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5343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959761AC-4AF6-3BF8-89B8-AABCAFACBAB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8B658057-84FB-5C4F-80CA-17E1EBE12C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17A0CBD-CBE1-F059-AE5D-88E3CD0467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3C1EF8-0C4E-1CF7-BBD9-3A99F0A46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742C019-F575-B145-11EE-00075B9D8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6543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FA897A-FE9B-1AFC-1960-0089865EE5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7192A78-2BCE-2F95-87A9-CF3287DCBF0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A0F9C46-3F00-116D-3C37-40BC2FA75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066139D-856C-3443-1FFD-86452E61D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914575-45C5-E38E-38D0-F082FC37A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677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7D1C64-54EB-6104-59E2-2314B2359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CF33515-E661-09C4-75D6-8B13FC0C2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88AB198-2C4A-49DB-B4DB-6560F2656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7DADF76-C595-B351-9C6D-F5AAA2F3C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4A57529-28EB-6847-36CD-F3AAC8624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7677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53971D-E7CC-7755-A964-037DDF8C5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B4F9C1A-1F75-52F8-8436-2DB39A7DFB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056B8C7-E84B-D8B9-7F8D-657A2FC8E0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8152273-425F-7E27-4ADD-FD025BEDF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92902A5-DC66-5B96-7830-A245C9874C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BE2D3D3-6B19-C6B8-A2A5-62B99DB14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5386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EBE00C-59DF-F01D-D9BB-BAAB5217B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256E6FD-5CE7-762A-80A0-A35EA90E33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E1320B9-8BD7-2F67-C8BB-11DD10B035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A2A78E0-7F42-5240-6297-E5F523363A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4179E32-F762-4C7D-05DE-C108D8A6FC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42FD27BC-E7CE-0413-4344-82B8524B1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1EBE60C-A690-DE67-BE4A-8E93DC0D7D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128F829-3A4E-94D1-8FC2-4BC280B8C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5058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A0F176-19BF-CC0E-5D90-F2B30CAEAA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741FA5E-431D-3C0A-2B68-57DC20F123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4D40B6F-7245-568E-112E-D4EFEE83E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D4F6874-3BB6-CDDA-290E-7D5A2458D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9544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D3708E3-EF6C-F91C-0D39-28218B3AC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6FDF788-4CB0-9416-59FD-986CB2B5C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0F3431E-2113-2FFF-4119-5C97C8BF8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0881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63CC4E0-2305-48B3-5531-D3B449C848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5690774-8FBC-9AC4-95E5-46B4D70DB2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307AC8C-FCD0-926F-993C-2D9E6312E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974606-4397-0C03-13E6-28B63C2E3B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FC50FEB-0EDB-4C0D-5887-7EF71AA28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E018430-B9FB-53BC-9E9E-78B7E47F2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7621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570B023-AE27-03B8-FEFD-DE8CF09AF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83B8846-E488-61A5-2649-569EB39873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FE9CCBA-8B6B-C9BB-4071-52662BB15C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F61F843-299E-8EC6-F740-F28DBE9FF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5A3A2D1-A62E-C7DD-19BB-73849FF30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82AF263-4B0D-413F-6565-169CC716A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1982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227ED1F2-22F2-D0E9-7858-02BE0F1576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033CE6A-F6C6-099B-1E02-177699BC11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C94ED2F-E584-F1B7-468A-46D753B1FE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48DAF2A-898E-4585-B267-5A7DF817E558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EF62F8D-EEC5-FF54-9038-E69D993F53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396C5AE-B6D4-2F1C-42C6-A46A394F53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72D806-9F33-45C6-A750-F5235B318E4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9587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1.png"/><Relationship Id="rId2" Type="http://schemas.openxmlformats.org/officeDocument/2006/relationships/video" Target="../media/media1.mp4"/><Relationship Id="rId16" Type="http://schemas.openxmlformats.org/officeDocument/2006/relationships/image" Target="../media/image5.pn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slideLayout" Target="../slideLayouts/slideLayout7.xml"/><Relationship Id="rId5" Type="http://schemas.microsoft.com/office/2007/relationships/media" Target="../media/media3.mp4"/><Relationship Id="rId15" Type="http://schemas.openxmlformats.org/officeDocument/2006/relationships/image" Target="../media/image4.png"/><Relationship Id="rId10" Type="http://schemas.openxmlformats.org/officeDocument/2006/relationships/video" Target="../media/media5.mp4"/><Relationship Id="rId4" Type="http://schemas.openxmlformats.org/officeDocument/2006/relationships/video" Target="../media/media2.mp4"/><Relationship Id="rId9" Type="http://schemas.microsoft.com/office/2007/relationships/media" Target="../media/media5.mp4"/><Relationship Id="rId1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F54F6A-6BCB-FF7A-9C09-609C67E5D9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2-12-2024_21-29-29">
            <a:hlinkClick r:id="" action="ppaction://media"/>
            <a:extLst>
              <a:ext uri="{FF2B5EF4-FFF2-40B4-BE49-F238E27FC236}">
                <a16:creationId xmlns:a16="http://schemas.microsoft.com/office/drawing/2014/main" id="{396229FF-7173-2BB4-7E2F-6A92EC65D95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793922" y="265244"/>
            <a:ext cx="1825203" cy="3877850"/>
          </a:xfrm>
          <a:prstGeom prst="rect">
            <a:avLst/>
          </a:prstGeom>
        </p:spPr>
      </p:pic>
      <p:pic>
        <p:nvPicPr>
          <p:cNvPr id="3" name="12-12-2024_21-31-11">
            <a:hlinkClick r:id="" action="ppaction://media"/>
            <a:extLst>
              <a:ext uri="{FF2B5EF4-FFF2-40B4-BE49-F238E27FC236}">
                <a16:creationId xmlns:a16="http://schemas.microsoft.com/office/drawing/2014/main" id="{C6C8E6D9-3DC0-4D8A-83E0-0AA91438D4D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2784860" y="265244"/>
            <a:ext cx="2245071" cy="3877850"/>
          </a:xfrm>
          <a:prstGeom prst="rect">
            <a:avLst/>
          </a:prstGeom>
        </p:spPr>
      </p:pic>
      <p:pic>
        <p:nvPicPr>
          <p:cNvPr id="4" name="12-12-2024_21-32-01">
            <a:hlinkClick r:id="" action="ppaction://media"/>
            <a:extLst>
              <a:ext uri="{FF2B5EF4-FFF2-40B4-BE49-F238E27FC236}">
                <a16:creationId xmlns:a16="http://schemas.microsoft.com/office/drawing/2014/main" id="{8BA5BF78-6DB9-D903-3282-5F837CC16179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5181960" y="265244"/>
            <a:ext cx="1990425" cy="3877850"/>
          </a:xfrm>
          <a:prstGeom prst="rect">
            <a:avLst/>
          </a:prstGeom>
        </p:spPr>
      </p:pic>
      <p:pic>
        <p:nvPicPr>
          <p:cNvPr id="5" name="12-12-2024_21-33-03">
            <a:hlinkClick r:id="" action="ppaction://media"/>
            <a:extLst>
              <a:ext uri="{FF2B5EF4-FFF2-40B4-BE49-F238E27FC236}">
                <a16:creationId xmlns:a16="http://schemas.microsoft.com/office/drawing/2014/main" id="{CE746218-57D5-1927-6C7B-2C2053CD869A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7358757" y="226143"/>
            <a:ext cx="1753498" cy="3916951"/>
          </a:xfrm>
          <a:prstGeom prst="rect">
            <a:avLst/>
          </a:prstGeom>
        </p:spPr>
      </p:pic>
      <p:pic>
        <p:nvPicPr>
          <p:cNvPr id="6" name="12-12-2024_21-36-23">
            <a:hlinkClick r:id="" action="ppaction://media"/>
            <a:extLst>
              <a:ext uri="{FF2B5EF4-FFF2-40B4-BE49-F238E27FC236}">
                <a16:creationId xmlns:a16="http://schemas.microsoft.com/office/drawing/2014/main" id="{A5DAE89D-8719-D0CF-B4ED-AD3C406FA828}"/>
              </a:ext>
            </a:extLst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16"/>
          <a:stretch>
            <a:fillRect/>
          </a:stretch>
        </p:blipFill>
        <p:spPr>
          <a:xfrm>
            <a:off x="9270086" y="226143"/>
            <a:ext cx="1746851" cy="3850045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92E71179-31CF-DB4F-1F11-ACCE8AA53086}"/>
              </a:ext>
            </a:extLst>
          </p:cNvPr>
          <p:cNvSpPr txBox="1"/>
          <p:nvPr/>
        </p:nvSpPr>
        <p:spPr>
          <a:xfrm>
            <a:off x="1245499" y="414667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Video 1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8A36E5B5-533A-E532-7B95-EA472B521F90}"/>
              </a:ext>
            </a:extLst>
          </p:cNvPr>
          <p:cNvSpPr txBox="1"/>
          <p:nvPr/>
        </p:nvSpPr>
        <p:spPr>
          <a:xfrm>
            <a:off x="3446371" y="414667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Video 2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9E382098-87CF-4C0E-B098-9D251535027B}"/>
              </a:ext>
            </a:extLst>
          </p:cNvPr>
          <p:cNvSpPr txBox="1"/>
          <p:nvPr/>
        </p:nvSpPr>
        <p:spPr>
          <a:xfrm>
            <a:off x="5691442" y="414667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Video 3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21F9DA0-3877-5384-1EE5-56974BD1F9D0}"/>
              </a:ext>
            </a:extLst>
          </p:cNvPr>
          <p:cNvSpPr txBox="1"/>
          <p:nvPr/>
        </p:nvSpPr>
        <p:spPr>
          <a:xfrm>
            <a:off x="7774482" y="4185773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Video 4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968CD097-5134-AB08-9BF6-CF2A64152940}"/>
              </a:ext>
            </a:extLst>
          </p:cNvPr>
          <p:cNvSpPr txBox="1"/>
          <p:nvPr/>
        </p:nvSpPr>
        <p:spPr>
          <a:xfrm>
            <a:off x="9656402" y="4143094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Video 5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A20742DE-B96A-FF67-C722-65432258FADD}"/>
              </a:ext>
            </a:extLst>
          </p:cNvPr>
          <p:cNvSpPr txBox="1"/>
          <p:nvPr/>
        </p:nvSpPr>
        <p:spPr>
          <a:xfrm>
            <a:off x="1012723" y="4906297"/>
            <a:ext cx="889819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dirty="0"/>
              <a:t>Video 1. Digital subtraction angiogram, showing subtotal occlusion of the CFA.</a:t>
            </a:r>
          </a:p>
          <a:p>
            <a:r>
              <a:rPr lang="en-AU" sz="1600" dirty="0"/>
              <a:t>Video 2. Fluoroscopy images during </a:t>
            </a:r>
            <a:r>
              <a:rPr lang="en-AU" sz="1600" dirty="0" err="1"/>
              <a:t>Rotarex</a:t>
            </a:r>
            <a:r>
              <a:rPr lang="en-AU" sz="1600" dirty="0"/>
              <a:t> thrombectomy.</a:t>
            </a:r>
          </a:p>
          <a:p>
            <a:r>
              <a:rPr lang="en-AU" sz="1600" dirty="0"/>
              <a:t>Video 3. Digital subtraction angiogram after several passages with the 8F </a:t>
            </a:r>
            <a:r>
              <a:rPr lang="en-AU" sz="1600" dirty="0" err="1"/>
              <a:t>Rotarex</a:t>
            </a:r>
            <a:r>
              <a:rPr lang="en-AU" sz="1600" dirty="0"/>
              <a:t> catheter.</a:t>
            </a:r>
          </a:p>
          <a:p>
            <a:r>
              <a:rPr lang="en-AU" sz="1600" dirty="0"/>
              <a:t>Video 4. Digital subtraction angiogram after balloon angioplasty.</a:t>
            </a:r>
          </a:p>
          <a:p>
            <a:r>
              <a:rPr lang="en-AU" sz="1600" dirty="0"/>
              <a:t>Video 5. Cine angiogram after balloon angioplasty, showing brisk flow to the foot of the patient.</a:t>
            </a:r>
          </a:p>
        </p:txBody>
      </p:sp>
    </p:spTree>
    <p:extLst>
      <p:ext uri="{BB962C8B-B14F-4D97-AF65-F5344CB8AC3E}">
        <p14:creationId xmlns:p14="http://schemas.microsoft.com/office/powerpoint/2010/main" val="899776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12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133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817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924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2521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23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24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5" fill="hold">
                      <p:stCondLst>
                        <p:cond delay="0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8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29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30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1" fill="hold">
                      <p:stCondLst>
                        <p:cond delay="0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4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35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41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4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3" fill="hold">
                      <p:stCondLst>
                        <p:cond delay="0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4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4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9" fill="hold">
                      <p:stCondLst>
                        <p:cond delay="0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Breitbild</PresentationFormat>
  <Paragraphs>10</Paragraphs>
  <Slides>1</Slides>
  <Notes>0</Notes>
  <HiddenSlides>0</HiddenSlides>
  <MMClips>5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Grigorios Korosoglou</dc:creator>
  <cp:lastModifiedBy>Grigorios Korosoglou</cp:lastModifiedBy>
  <cp:revision>13</cp:revision>
  <dcterms:created xsi:type="dcterms:W3CDTF">2024-12-01T18:47:36Z</dcterms:created>
  <dcterms:modified xsi:type="dcterms:W3CDTF">2025-01-05T14:15:30Z</dcterms:modified>
</cp:coreProperties>
</file>